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32"/>
    <p:restoredTop sz="94595"/>
  </p:normalViewPr>
  <p:slideViewPr>
    <p:cSldViewPr snapToGrid="0" snapToObjects="1">
      <p:cViewPr varScale="1">
        <p:scale>
          <a:sx n="76" d="100"/>
          <a:sy n="76" d="100"/>
        </p:scale>
        <p:origin x="292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0810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987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214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913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591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5549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549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36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465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177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3265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2986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10075181-4FE8-D447-9E99-84491487DCB5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816000" y="4114800"/>
            <a:ext cx="2286000" cy="15087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6599F5E-FCE3-AE43-ABDC-7E53399CBDA5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562400" y="4114800"/>
            <a:ext cx="2286000" cy="150876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F0FD710-6E03-2D49-BFEE-899B7E5F6B1E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816000" y="878400"/>
            <a:ext cx="2286000" cy="27432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05E654D-2EB5-564B-B885-7D0DCA82D13C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562400" y="878400"/>
            <a:ext cx="2286000" cy="27432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29370" y="278296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Figure 2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409444" y="3307576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092769" y="330228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02824" y="3051607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6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93517" y="2805143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UKF-NB-3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805463" y="2048417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2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96178" y="1036317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LF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797521" y="1292266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GP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98840" y="1545531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NB-S-124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793519" y="2291426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IMR-32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803041" y="4440296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LAN-6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803041" y="5197062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SK-N-AS</a:t>
            </a:r>
          </a:p>
        </p:txBody>
      </p:sp>
      <p:sp>
        <p:nvSpPr>
          <p:cNvPr id="75" name="TextBox 74"/>
          <p:cNvSpPr txBox="1"/>
          <p:nvPr/>
        </p:nvSpPr>
        <p:spPr>
          <a:xfrm rot="-5400000">
            <a:off x="-128431" y="4698738"/>
            <a:ext cx="16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ot MYCN-amplified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2766162" y="3303794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40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3450185" y="3303794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60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3656463" y="3303794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4339788" y="3303794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5013181" y="3303794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40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5695441" y="3303794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60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1634034" y="3597699"/>
            <a:ext cx="43733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n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) in the presence of ABCB1 inhibitors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1658119" y="843583"/>
            <a:ext cx="203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verapamil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3949441" y="843157"/>
            <a:ext cx="203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zosuquidar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797063" y="2542866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CHP-134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798390" y="1796012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IMR-5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1412982" y="5416373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2096307" y="5411077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2769700" y="541259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40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3453723" y="541259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60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3660001" y="541259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4343326" y="541259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5016719" y="541259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40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5698979" y="541259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60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1637572" y="5706496"/>
            <a:ext cx="43733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n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) in the presence of ABCB1 inhibitors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802950" y="4941002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SHEP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803041" y="4695812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SK-N-SH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803041" y="4185794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GIMEN</a:t>
            </a:r>
          </a:p>
        </p:txBody>
      </p:sp>
      <p:sp>
        <p:nvSpPr>
          <p:cNvPr id="111" name="TextBox 110"/>
          <p:cNvSpPr txBox="1"/>
          <p:nvPr/>
        </p:nvSpPr>
        <p:spPr>
          <a:xfrm rot="-5400000">
            <a:off x="-128053" y="2001605"/>
            <a:ext cx="16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MYCN-amplified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1661661" y="4015635"/>
            <a:ext cx="203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verapamil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3952983" y="4015209"/>
            <a:ext cx="203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zosuquidar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32908" y="632717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32000" y="6124038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727797" y="6432708"/>
            <a:ext cx="3657600" cy="822960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1856593" y="6262652"/>
            <a:ext cx="33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SH-EP-</a:t>
            </a:r>
            <a:r>
              <a:rPr lang="en-GB" sz="1200" i="1" dirty="0">
                <a:latin typeface="Arial" charset="0"/>
                <a:ea typeface="Arial" charset="0"/>
                <a:cs typeface="Arial" charset="0"/>
              </a:rPr>
              <a:t>MYCN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TET21N)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 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976707" y="6519036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MYCN low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793517" y="6884088"/>
            <a:ext cx="1118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MYCN high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586648" y="716365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280072" y="7158355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5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4974189" y="7159869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0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871499" y="7397076"/>
            <a:ext cx="33809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n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65506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1</TotalTime>
  <Words>79</Words>
  <Application>Microsoft Macintosh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Michaelis</dc:creator>
  <cp:lastModifiedBy>Microsoft Office User</cp:lastModifiedBy>
  <cp:revision>63</cp:revision>
  <dcterms:created xsi:type="dcterms:W3CDTF">2016-10-07T17:18:31Z</dcterms:created>
  <dcterms:modified xsi:type="dcterms:W3CDTF">2020-02-20T21:05:18Z</dcterms:modified>
</cp:coreProperties>
</file>